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714" y="-18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AR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426181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709712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95245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46121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961198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155143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2336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675557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863064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606875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AR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149951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66193-C79A-4D2E-A0B9-94F8CBBD28AD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B9878-1D37-4807-BEA0-F986C23AA814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85650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5380" y="357158"/>
            <a:ext cx="8781239" cy="5149076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34B90DE9-50A3-B3B9-2F34-13AAD4E89214}"/>
              </a:ext>
            </a:extLst>
          </p:cNvPr>
          <p:cNvSpPr txBox="1"/>
          <p:nvPr/>
        </p:nvSpPr>
        <p:spPr>
          <a:xfrm>
            <a:off x="1812758" y="5720112"/>
            <a:ext cx="8566484" cy="12179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  <a:buNone/>
            </a:pPr>
            <a:r>
              <a:rPr lang="en-US" sz="1000" b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Fig. S2. Cluster dendrogram with </a:t>
            </a:r>
            <a:r>
              <a:rPr lang="en-US" sz="1000" b="1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000" b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−values (%) for RAPD analysis.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The presence or absence of a particular polymorphic band in the RAPD assays was used as a binary score (present = 1, absent = 0) to perform hierarchical clustering using the “</a:t>
            </a:r>
            <a:r>
              <a:rPr lang="en-US" sz="1000" dirty="0" err="1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vclust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” R package (Suzuki and </a:t>
            </a:r>
            <a:r>
              <a:rPr lang="en-US" sz="1000" dirty="0" err="1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Shimodaira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2006), with Manhattan distance and average agglomerative clustering. There are shown the approximately unbiased </a:t>
            </a:r>
            <a:r>
              <a:rPr lang="en-US" sz="1000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-values (AU </a:t>
            </a:r>
            <a:r>
              <a:rPr lang="en-US" sz="1000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-values) that were calculated by multiscale bootstrap resampling with 10,000 repetitions. Selected strains are indicated in bold as well as their number of RAPD polymorphic cluster.</a:t>
            </a:r>
            <a:endParaRPr lang="es-AR" sz="1000" dirty="0">
              <a:effectLst/>
              <a:latin typeface="Arial" panose="020B0604020202020204" pitchFamily="34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8422042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6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espariz</dc:creator>
  <cp:lastModifiedBy>Martin Espariz</cp:lastModifiedBy>
  <cp:revision>4</cp:revision>
  <dcterms:created xsi:type="dcterms:W3CDTF">2020-10-28T17:05:34Z</dcterms:created>
  <dcterms:modified xsi:type="dcterms:W3CDTF">2025-05-23T18:46:38Z</dcterms:modified>
</cp:coreProperties>
</file>